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2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2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95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56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248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463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266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905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7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59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13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96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59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8789182F-B3E3-4443-8191-F5AF0A89095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9868" y="2276897"/>
            <a:ext cx="2889587" cy="209960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26AB1BC0-C65C-4AC8-9BB5-D48827419A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38843" y="2276897"/>
            <a:ext cx="2889587" cy="2099608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33F2A73B-CEBB-4551-A2C5-AAD031656E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4257" y="6627667"/>
            <a:ext cx="2932069" cy="2130477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94E2870B-6187-4ED0-8F00-F79B63D47F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63707" y="6627667"/>
            <a:ext cx="2932069" cy="2130477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1FB2BD3D-F2E5-4E42-93FF-94277C2D7A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2637" y="4531894"/>
            <a:ext cx="2848354" cy="2069649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B3FCAAFE-04FE-431B-A4BB-15993308282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2087" y="4531894"/>
            <a:ext cx="2848354" cy="206964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31DE371-69EA-4959-93CB-76CEB35C94E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8996" y="135697"/>
            <a:ext cx="2879826" cy="2092517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1A2A3A36-5853-49D8-B883-C0B72CB4E22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38446" y="135697"/>
            <a:ext cx="2879826" cy="2092517"/>
          </a:xfrm>
          <a:prstGeom prst="rect">
            <a:avLst/>
          </a:prstGeom>
        </p:spPr>
      </p:pic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0DAAB9BA-9AD0-4653-BAFB-15AF093AEFA6}"/>
              </a:ext>
            </a:extLst>
          </p:cNvPr>
          <p:cNvSpPr txBox="1"/>
          <p:nvPr/>
        </p:nvSpPr>
        <p:spPr>
          <a:xfrm rot="16200000">
            <a:off x="2866690" y="751484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0C0AD229-B818-4AC0-A655-FD8491A72043}"/>
              </a:ext>
            </a:extLst>
          </p:cNvPr>
          <p:cNvSpPr txBox="1"/>
          <p:nvPr/>
        </p:nvSpPr>
        <p:spPr>
          <a:xfrm>
            <a:off x="5202061" y="858572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253DB289-338F-4C58-95B0-79FC71E63187}"/>
              </a:ext>
            </a:extLst>
          </p:cNvPr>
          <p:cNvSpPr txBox="1"/>
          <p:nvPr/>
        </p:nvSpPr>
        <p:spPr>
          <a:xfrm>
            <a:off x="1451441" y="6916451"/>
            <a:ext cx="19127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15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5.0 (1.30: 0.93-1.80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5.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6.7 (0.74: 0.51-1.08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7F652514-7D36-436E-8F37-887E921337D7}"/>
              </a:ext>
            </a:extLst>
          </p:cNvPr>
          <p:cNvSpPr txBox="1"/>
          <p:nvPr/>
        </p:nvSpPr>
        <p:spPr>
          <a:xfrm rot="16200000">
            <a:off x="-342530" y="751484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AE912B20-C21B-4698-8ABD-79563DB79683}"/>
              </a:ext>
            </a:extLst>
          </p:cNvPr>
          <p:cNvSpPr txBox="1"/>
          <p:nvPr/>
        </p:nvSpPr>
        <p:spPr>
          <a:xfrm>
            <a:off x="1992841" y="858572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70BF3ECA-99B7-454B-8088-761567B9774A}"/>
              </a:ext>
            </a:extLst>
          </p:cNvPr>
          <p:cNvSpPr txBox="1"/>
          <p:nvPr/>
        </p:nvSpPr>
        <p:spPr>
          <a:xfrm>
            <a:off x="4595343" y="6882304"/>
            <a:ext cx="19127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03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5.0 (0.97: 0.66-1.42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5.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6.7 (1.03: 0.67-1.60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5BE82989-5AA8-4593-A223-3CE356AB0A28}"/>
              </a:ext>
            </a:extLst>
          </p:cNvPr>
          <p:cNvSpPr txBox="1"/>
          <p:nvPr/>
        </p:nvSpPr>
        <p:spPr>
          <a:xfrm rot="16200000">
            <a:off x="2866690" y="532028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27EC8EC9-91ED-460C-AEA4-F1F5FE84C510}"/>
              </a:ext>
            </a:extLst>
          </p:cNvPr>
          <p:cNvSpPr txBox="1"/>
          <p:nvPr/>
        </p:nvSpPr>
        <p:spPr>
          <a:xfrm>
            <a:off x="5202061" y="644831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FAB2FAC2-DC10-4340-B17D-D66ACA915699}"/>
              </a:ext>
            </a:extLst>
          </p:cNvPr>
          <p:cNvSpPr txBox="1"/>
          <p:nvPr/>
        </p:nvSpPr>
        <p:spPr>
          <a:xfrm>
            <a:off x="1023519" y="4721891"/>
            <a:ext cx="257796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14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5.1 (1.10: 0.88-1.36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5.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6.7 (0.89: 0.68-1.17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DA6F8EAD-B40A-427D-BAE4-F736D68BA5E8}"/>
              </a:ext>
            </a:extLst>
          </p:cNvPr>
          <p:cNvSpPr txBox="1"/>
          <p:nvPr/>
        </p:nvSpPr>
        <p:spPr>
          <a:xfrm rot="16200000">
            <a:off x="-342530" y="532028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E3C24CBE-6E96-46EF-8626-9CE070DA2352}"/>
              </a:ext>
            </a:extLst>
          </p:cNvPr>
          <p:cNvSpPr txBox="1"/>
          <p:nvPr/>
        </p:nvSpPr>
        <p:spPr>
          <a:xfrm>
            <a:off x="1992841" y="644831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A08D6C39-5F49-4D8E-AED9-90DCFD776D04}"/>
              </a:ext>
            </a:extLst>
          </p:cNvPr>
          <p:cNvSpPr txBox="1"/>
          <p:nvPr/>
        </p:nvSpPr>
        <p:spPr>
          <a:xfrm>
            <a:off x="4157744" y="4743579"/>
            <a:ext cx="253752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05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5.1 (0.98: 0.81-1.20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5.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6.7 (1.03: 0.76-1.3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2CACE123-A691-40B8-B614-9FDCCA59422F}"/>
              </a:ext>
            </a:extLst>
          </p:cNvPr>
          <p:cNvSpPr txBox="1"/>
          <p:nvPr/>
        </p:nvSpPr>
        <p:spPr>
          <a:xfrm rot="16200000">
            <a:off x="2866690" y="311429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D0488BD6-9678-424E-BD97-1290CA325123}"/>
              </a:ext>
            </a:extLst>
          </p:cNvPr>
          <p:cNvSpPr txBox="1"/>
          <p:nvPr/>
        </p:nvSpPr>
        <p:spPr>
          <a:xfrm>
            <a:off x="5202061" y="424232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91755523-1487-4ECE-A216-71609BFF880C}"/>
              </a:ext>
            </a:extLst>
          </p:cNvPr>
          <p:cNvSpPr txBox="1"/>
          <p:nvPr/>
        </p:nvSpPr>
        <p:spPr>
          <a:xfrm>
            <a:off x="1531451" y="2506376"/>
            <a:ext cx="19127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8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4.8 (2.10: 1.00-4.39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9.4 (0.35: 0.20-1.00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6.4 (1.22: 1.00-1.50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7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2 (0.67: 0.45-1.00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55043536-9762-4F5E-9172-005248EE6075}"/>
              </a:ext>
            </a:extLst>
          </p:cNvPr>
          <p:cNvSpPr txBox="1"/>
          <p:nvPr/>
        </p:nvSpPr>
        <p:spPr>
          <a:xfrm rot="16200000">
            <a:off x="-342530" y="311429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77D56A66-188C-4059-9A80-BE43A00F263D}"/>
              </a:ext>
            </a:extLst>
          </p:cNvPr>
          <p:cNvSpPr txBox="1"/>
          <p:nvPr/>
        </p:nvSpPr>
        <p:spPr>
          <a:xfrm>
            <a:off x="1992841" y="424232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98BAE34B-FBD6-4D0A-B422-D876270A87A4}"/>
              </a:ext>
            </a:extLst>
          </p:cNvPr>
          <p:cNvSpPr txBox="1"/>
          <p:nvPr/>
        </p:nvSpPr>
        <p:spPr>
          <a:xfrm>
            <a:off x="4702039" y="2501585"/>
            <a:ext cx="19127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89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6.4 (1.21: 0.99-1.47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7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2 (0.69: 0.46-1.03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4E5E229F-D551-4C4E-BFCD-0091FA980A6E}"/>
              </a:ext>
            </a:extLst>
          </p:cNvPr>
          <p:cNvSpPr txBox="1"/>
          <p:nvPr/>
        </p:nvSpPr>
        <p:spPr>
          <a:xfrm rot="16200000">
            <a:off x="2866690" y="9540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E20195C7-D441-47D0-B46A-B24DD1DB20D7}"/>
              </a:ext>
            </a:extLst>
          </p:cNvPr>
          <p:cNvSpPr txBox="1"/>
          <p:nvPr/>
        </p:nvSpPr>
        <p:spPr>
          <a:xfrm>
            <a:off x="5202061" y="20820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DF43DDAF-3D99-4658-8875-51343749EB8C}"/>
              </a:ext>
            </a:extLst>
          </p:cNvPr>
          <p:cNvSpPr txBox="1"/>
          <p:nvPr/>
        </p:nvSpPr>
        <p:spPr>
          <a:xfrm>
            <a:off x="935014" y="317531"/>
            <a:ext cx="250920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931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6.5 (1.11: 0.93-1.33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7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2 (0.78: 0.51-1.1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13FAB6CF-3D64-4E31-B310-BCC4CA74AB82}"/>
              </a:ext>
            </a:extLst>
          </p:cNvPr>
          <p:cNvSpPr txBox="1"/>
          <p:nvPr/>
        </p:nvSpPr>
        <p:spPr>
          <a:xfrm rot="16200000">
            <a:off x="-342530" y="9540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94E8036C-C56E-4D82-A1AF-36336FC00E1A}"/>
              </a:ext>
            </a:extLst>
          </p:cNvPr>
          <p:cNvSpPr txBox="1"/>
          <p:nvPr/>
        </p:nvSpPr>
        <p:spPr>
          <a:xfrm>
            <a:off x="1992841" y="20820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1F76EFB3-F0B8-4005-9BB2-F382731F3048}"/>
              </a:ext>
            </a:extLst>
          </p:cNvPr>
          <p:cNvSpPr txBox="1"/>
          <p:nvPr/>
        </p:nvSpPr>
        <p:spPr>
          <a:xfrm>
            <a:off x="4094069" y="325666"/>
            <a:ext cx="259649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91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6.5 (1.06: 0.88-1.29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7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2 (0.86: 0.55-1.3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704850" y="10829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993868" y="11393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0" y="8735394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6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ose-response relationships of SMI with incident disability and mortality risks, excluding disabilities or deaths that occurred during the </a:t>
            </a:r>
            <a:r>
              <a:rPr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first tw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ja-JP" sz="11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years of follow-up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F66FDD1-38C4-4C41-8CDD-B1C9287E5928}"/>
              </a:ext>
            </a:extLst>
          </p:cNvPr>
          <p:cNvSpPr txBox="1"/>
          <p:nvPr/>
        </p:nvSpPr>
        <p:spPr>
          <a:xfrm>
            <a:off x="0" y="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3D6331C-010B-4301-B5A4-50F6B8ED5345}"/>
              </a:ext>
            </a:extLst>
          </p:cNvPr>
          <p:cNvSpPr txBox="1"/>
          <p:nvPr/>
        </p:nvSpPr>
        <p:spPr>
          <a:xfrm>
            <a:off x="708660" y="226094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AE4DD2A-D64A-4D19-89B3-77D9C2248B6D}"/>
              </a:ext>
            </a:extLst>
          </p:cNvPr>
          <p:cNvSpPr txBox="1"/>
          <p:nvPr/>
        </p:nvSpPr>
        <p:spPr>
          <a:xfrm>
            <a:off x="3997678" y="226658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8155764-E544-4939-B205-5BD01424B661}"/>
              </a:ext>
            </a:extLst>
          </p:cNvPr>
          <p:cNvSpPr txBox="1"/>
          <p:nvPr/>
        </p:nvSpPr>
        <p:spPr>
          <a:xfrm>
            <a:off x="15240" y="434721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C058EE1-9BBA-4DE6-8723-94ACDB0DCF75}"/>
              </a:ext>
            </a:extLst>
          </p:cNvPr>
          <p:cNvSpPr txBox="1"/>
          <p:nvPr/>
        </p:nvSpPr>
        <p:spPr>
          <a:xfrm>
            <a:off x="708660" y="450122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BC9DF35-8B39-4895-B716-1EDFAA7FAD89}"/>
              </a:ext>
            </a:extLst>
          </p:cNvPr>
          <p:cNvSpPr txBox="1"/>
          <p:nvPr/>
        </p:nvSpPr>
        <p:spPr>
          <a:xfrm>
            <a:off x="3997678" y="450686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EBABE77-10C9-41FE-93EC-DF11EB866820}"/>
              </a:ext>
            </a:extLst>
          </p:cNvPr>
          <p:cNvSpPr txBox="1"/>
          <p:nvPr/>
        </p:nvSpPr>
        <p:spPr>
          <a:xfrm>
            <a:off x="712470" y="665387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DE9FB2B-8A6F-4D7D-BDDE-B109B99A8EB2}"/>
              </a:ext>
            </a:extLst>
          </p:cNvPr>
          <p:cNvSpPr txBox="1"/>
          <p:nvPr/>
        </p:nvSpPr>
        <p:spPr>
          <a:xfrm>
            <a:off x="4001488" y="665951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6460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08</TotalTime>
  <Words>614</Words>
  <Application>Microsoft Office PowerPoint</Application>
  <PresentationFormat>画面に合わせる (4:3)</PresentationFormat>
  <Paragraphs>9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Seino</dc:creator>
  <cp:lastModifiedBy>Seino Satoshi</cp:lastModifiedBy>
  <cp:revision>356</cp:revision>
  <cp:lastPrinted>2019-04-05T09:48:00Z</cp:lastPrinted>
  <dcterms:created xsi:type="dcterms:W3CDTF">2019-01-07T07:45:10Z</dcterms:created>
  <dcterms:modified xsi:type="dcterms:W3CDTF">2022-02-10T10:04:08Z</dcterms:modified>
</cp:coreProperties>
</file>